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9202400" cy="64008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>
          <p15:clr>
            <a:srgbClr val="A4A3A4"/>
          </p15:clr>
        </p15:guide>
        <p15:guide id="2" pos="60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32" y="918"/>
      </p:cViewPr>
      <p:guideLst>
        <p:guide orient="horz" pos="2016"/>
        <p:guide pos="60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R\Downloads\SituationBreak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stacked"/>
        <c:varyColors val="0"/>
        <c:ser>
          <c:idx val="0"/>
          <c:order val="0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B$11:$B$19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C$11:$C$19</c:f>
              <c:numCache>
                <c:formatCode>General</c:formatCode>
                <c:ptCount val="9"/>
                <c:pt idx="0">
                  <c:v>1.1666666666666667</c:v>
                </c:pt>
                <c:pt idx="1">
                  <c:v>0.91666666666666663</c:v>
                </c:pt>
                <c:pt idx="2">
                  <c:v>0.91666666666666663</c:v>
                </c:pt>
                <c:pt idx="3">
                  <c:v>1.5</c:v>
                </c:pt>
                <c:pt idx="4">
                  <c:v>1.75</c:v>
                </c:pt>
                <c:pt idx="5">
                  <c:v>1.8833333333333333</c:v>
                </c:pt>
                <c:pt idx="6">
                  <c:v>1.8333333333333333</c:v>
                </c:pt>
                <c:pt idx="7">
                  <c:v>1.25</c:v>
                </c:pt>
                <c:pt idx="8">
                  <c:v>1.9</c:v>
                </c:pt>
              </c:numCache>
            </c:numRef>
          </c:val>
        </c:ser>
        <c:ser>
          <c:idx val="2"/>
          <c:order val="2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D$11:$D$19</c:f>
              <c:numCache>
                <c:formatCode>General</c:formatCode>
                <c:ptCount val="9"/>
                <c:pt idx="0">
                  <c:v>1.0833333333333333</c:v>
                </c:pt>
                <c:pt idx="1">
                  <c:v>0.29999999999999993</c:v>
                </c:pt>
                <c:pt idx="2">
                  <c:v>1.2166666666666668</c:v>
                </c:pt>
                <c:pt idx="3">
                  <c:v>0.3833333333333333</c:v>
                </c:pt>
                <c:pt idx="4">
                  <c:v>0.39999999999999991</c:v>
                </c:pt>
                <c:pt idx="5">
                  <c:v>0.28333333333333321</c:v>
                </c:pt>
                <c:pt idx="6">
                  <c:v>0.41666666666666674</c:v>
                </c:pt>
                <c:pt idx="7">
                  <c:v>0.68333333333333335</c:v>
                </c:pt>
                <c:pt idx="8">
                  <c:v>7.7999999999999989</c:v>
                </c:pt>
              </c:numCache>
            </c:numRef>
          </c:val>
        </c:ser>
        <c:ser>
          <c:idx val="3"/>
          <c:order val="3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E$11:$E$19</c:f>
              <c:numCache>
                <c:formatCode>General</c:formatCode>
                <c:ptCount val="9"/>
                <c:pt idx="0">
                  <c:v>7.4166666666666661</c:v>
                </c:pt>
                <c:pt idx="1">
                  <c:v>0.95</c:v>
                </c:pt>
                <c:pt idx="2">
                  <c:v>7.8000000000000007</c:v>
                </c:pt>
                <c:pt idx="3">
                  <c:v>4.6666666666666661</c:v>
                </c:pt>
                <c:pt idx="4">
                  <c:v>0.35000000000000009</c:v>
                </c:pt>
                <c:pt idx="5">
                  <c:v>6.7833333333333332</c:v>
                </c:pt>
                <c:pt idx="6">
                  <c:v>1.75</c:v>
                </c:pt>
                <c:pt idx="7">
                  <c:v>0.56666666666666665</c:v>
                </c:pt>
                <c:pt idx="8">
                  <c:v>4.9666666666666668</c:v>
                </c:pt>
              </c:numCache>
            </c:numRef>
          </c:val>
        </c:ser>
        <c:ser>
          <c:idx val="4"/>
          <c:order val="4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F$11:$F$19</c:f>
              <c:numCache>
                <c:formatCode>General</c:formatCode>
                <c:ptCount val="9"/>
                <c:pt idx="0">
                  <c:v>0.66666666666666785</c:v>
                </c:pt>
                <c:pt idx="1">
                  <c:v>7.4166666666666679</c:v>
                </c:pt>
                <c:pt idx="2">
                  <c:v>1.2166666666666668</c:v>
                </c:pt>
                <c:pt idx="3">
                  <c:v>2.7333333333333334</c:v>
                </c:pt>
                <c:pt idx="4">
                  <c:v>3.833333333333333</c:v>
                </c:pt>
                <c:pt idx="5">
                  <c:v>1.7166666666666668</c:v>
                </c:pt>
                <c:pt idx="6">
                  <c:v>3.916666666666667</c:v>
                </c:pt>
                <c:pt idx="7">
                  <c:v>7.1999999999999993</c:v>
                </c:pt>
                <c:pt idx="8">
                  <c:v>7.2333333333333325</c:v>
                </c:pt>
              </c:numCache>
            </c:numRef>
          </c:val>
        </c:ser>
        <c:ser>
          <c:idx val="5"/>
          <c:order val="5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G$11:$G$19</c:f>
              <c:numCache>
                <c:formatCode>General</c:formatCode>
                <c:ptCount val="9"/>
                <c:pt idx="0">
                  <c:v>4.4166666666666661</c:v>
                </c:pt>
                <c:pt idx="1">
                  <c:v>0.91666666666666607</c:v>
                </c:pt>
                <c:pt idx="2">
                  <c:v>3.7333333333333325</c:v>
                </c:pt>
                <c:pt idx="3">
                  <c:v>0.96666666666666679</c:v>
                </c:pt>
                <c:pt idx="4">
                  <c:v>2.9666666666666677</c:v>
                </c:pt>
                <c:pt idx="5">
                  <c:v>4</c:v>
                </c:pt>
                <c:pt idx="6">
                  <c:v>1.833333333333333</c:v>
                </c:pt>
                <c:pt idx="7">
                  <c:v>0.43333333333333357</c:v>
                </c:pt>
                <c:pt idx="8">
                  <c:v>3.1000000000000014</c:v>
                </c:pt>
              </c:numCache>
            </c:numRef>
          </c:val>
        </c:ser>
        <c:ser>
          <c:idx val="6"/>
          <c:order val="6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H$11:$H$19</c:f>
              <c:numCache>
                <c:formatCode>General</c:formatCode>
                <c:ptCount val="9"/>
                <c:pt idx="0">
                  <c:v>0.5</c:v>
                </c:pt>
                <c:pt idx="1">
                  <c:v>4.75</c:v>
                </c:pt>
                <c:pt idx="2">
                  <c:v>7.6666666666666679</c:v>
                </c:pt>
                <c:pt idx="3">
                  <c:v>0.38333333333333286</c:v>
                </c:pt>
                <c:pt idx="4">
                  <c:v>1.0833333333333321</c:v>
                </c:pt>
                <c:pt idx="5">
                  <c:v>0.70000000000000107</c:v>
                </c:pt>
                <c:pt idx="6">
                  <c:v>0.33333333333333393</c:v>
                </c:pt>
                <c:pt idx="7">
                  <c:v>4.8333333333333339</c:v>
                </c:pt>
                <c:pt idx="8">
                  <c:v>14.5</c:v>
                </c:pt>
              </c:numCache>
            </c:numRef>
          </c:val>
        </c:ser>
        <c:ser>
          <c:idx val="7"/>
          <c:order val="7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I$11:$I$19</c:f>
              <c:numCache>
                <c:formatCode>General</c:formatCode>
                <c:ptCount val="9"/>
                <c:pt idx="0">
                  <c:v>6.25</c:v>
                </c:pt>
                <c:pt idx="1">
                  <c:v>7.283333333333335</c:v>
                </c:pt>
                <c:pt idx="2">
                  <c:v>17.233333333333331</c:v>
                </c:pt>
                <c:pt idx="3">
                  <c:v>0.20000000000000107</c:v>
                </c:pt>
                <c:pt idx="4">
                  <c:v>4.4166666666666679</c:v>
                </c:pt>
                <c:pt idx="5">
                  <c:v>6.1333333333333329</c:v>
                </c:pt>
                <c:pt idx="6">
                  <c:v>0.53333333333333321</c:v>
                </c:pt>
                <c:pt idx="7">
                  <c:v>6.6166666666666654</c:v>
                </c:pt>
                <c:pt idx="8">
                  <c:v>5.5</c:v>
                </c:pt>
              </c:numCache>
            </c:numRef>
          </c:val>
        </c:ser>
        <c:ser>
          <c:idx val="8"/>
          <c:order val="8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J$11:$J$19</c:f>
              <c:numCache>
                <c:formatCode>General</c:formatCode>
                <c:ptCount val="9"/>
                <c:pt idx="0">
                  <c:v>3.5</c:v>
                </c:pt>
                <c:pt idx="1">
                  <c:v>2.216666666666665</c:v>
                </c:pt>
                <c:pt idx="2">
                  <c:v>5.4833333333333343</c:v>
                </c:pt>
                <c:pt idx="3">
                  <c:v>3.4499999999999993</c:v>
                </c:pt>
                <c:pt idx="4">
                  <c:v>0.44999999999999929</c:v>
                </c:pt>
                <c:pt idx="5">
                  <c:v>1.033333333333335</c:v>
                </c:pt>
                <c:pt idx="6">
                  <c:v>0.54999999999999893</c:v>
                </c:pt>
                <c:pt idx="7">
                  <c:v>0.45000000000000284</c:v>
                </c:pt>
                <c:pt idx="8">
                  <c:v>2.5</c:v>
                </c:pt>
              </c:numCache>
            </c:numRef>
          </c:val>
        </c:ser>
        <c:ser>
          <c:idx val="9"/>
          <c:order val="9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K$11:$K$19</c:f>
              <c:numCache>
                <c:formatCode>General</c:formatCode>
                <c:ptCount val="9"/>
                <c:pt idx="0">
                  <c:v>14.56666666666667</c:v>
                </c:pt>
                <c:pt idx="1">
                  <c:v>14.833333333333336</c:v>
                </c:pt>
                <c:pt idx="2">
                  <c:v>2.5500000000000043</c:v>
                </c:pt>
                <c:pt idx="3">
                  <c:v>0.5</c:v>
                </c:pt>
                <c:pt idx="4">
                  <c:v>6.25</c:v>
                </c:pt>
                <c:pt idx="5">
                  <c:v>0.53333333333333144</c:v>
                </c:pt>
                <c:pt idx="6">
                  <c:v>1.3333333333333339</c:v>
                </c:pt>
                <c:pt idx="7">
                  <c:v>2.6499999999999986</c:v>
                </c:pt>
                <c:pt idx="8">
                  <c:v>4.5</c:v>
                </c:pt>
              </c:numCache>
            </c:numRef>
          </c:val>
        </c:ser>
        <c:ser>
          <c:idx val="10"/>
          <c:order val="10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L$11:$L$19</c:f>
              <c:numCache>
                <c:formatCode>General</c:formatCode>
                <c:ptCount val="9"/>
                <c:pt idx="0">
                  <c:v>5.5999999999999943</c:v>
                </c:pt>
                <c:pt idx="1">
                  <c:v>4.3499999999999943</c:v>
                </c:pt>
                <c:pt idx="2">
                  <c:v>5.6333333333333329</c:v>
                </c:pt>
                <c:pt idx="3">
                  <c:v>7.0499999999999989</c:v>
                </c:pt>
                <c:pt idx="4">
                  <c:v>0.5</c:v>
                </c:pt>
                <c:pt idx="5">
                  <c:v>0.18333333333333357</c:v>
                </c:pt>
                <c:pt idx="6">
                  <c:v>0.33333333333333393</c:v>
                </c:pt>
                <c:pt idx="7">
                  <c:v>15.400000000000002</c:v>
                </c:pt>
                <c:pt idx="8">
                  <c:v>12</c:v>
                </c:pt>
              </c:numCache>
            </c:numRef>
          </c:val>
        </c:ser>
        <c:ser>
          <c:idx val="11"/>
          <c:order val="11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M$11:$M$19</c:f>
              <c:numCache>
                <c:formatCode>General</c:formatCode>
                <c:ptCount val="9"/>
                <c:pt idx="0">
                  <c:v>2.3333333333333357</c:v>
                </c:pt>
                <c:pt idx="1">
                  <c:v>4.2166666666666686</c:v>
                </c:pt>
                <c:pt idx="2">
                  <c:v>10.549999999999997</c:v>
                </c:pt>
                <c:pt idx="3">
                  <c:v>0.76666666666666927</c:v>
                </c:pt>
                <c:pt idx="4">
                  <c:v>0.53333333333333499</c:v>
                </c:pt>
                <c:pt idx="5">
                  <c:v>0.80000000000000071</c:v>
                </c:pt>
                <c:pt idx="6">
                  <c:v>0.34999999999999964</c:v>
                </c:pt>
                <c:pt idx="7">
                  <c:v>3.8166666666666629</c:v>
                </c:pt>
              </c:numCache>
            </c:numRef>
          </c:val>
        </c:ser>
        <c:ser>
          <c:idx val="12"/>
          <c:order val="12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N$11:$N$19</c:f>
              <c:numCache>
                <c:formatCode>General</c:formatCode>
                <c:ptCount val="9"/>
                <c:pt idx="0">
                  <c:v>5.7666666666666657</c:v>
                </c:pt>
                <c:pt idx="1">
                  <c:v>4.7333333333333343</c:v>
                </c:pt>
                <c:pt idx="3">
                  <c:v>0.79999999999999716</c:v>
                </c:pt>
                <c:pt idx="4">
                  <c:v>0.54999999999999716</c:v>
                </c:pt>
                <c:pt idx="5">
                  <c:v>1</c:v>
                </c:pt>
                <c:pt idx="6">
                  <c:v>0.65000000000000036</c:v>
                </c:pt>
                <c:pt idx="7">
                  <c:v>0.60000000000000142</c:v>
                </c:pt>
              </c:numCache>
            </c:numRef>
          </c:val>
        </c:ser>
        <c:ser>
          <c:idx val="13"/>
          <c:order val="13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O$11:$O$19</c:f>
              <c:numCache>
                <c:formatCode>General</c:formatCode>
                <c:ptCount val="9"/>
                <c:pt idx="0">
                  <c:v>10.433333333333337</c:v>
                </c:pt>
                <c:pt idx="1">
                  <c:v>0.36666666666666714</c:v>
                </c:pt>
                <c:pt idx="3">
                  <c:v>1.3500000000000014</c:v>
                </c:pt>
                <c:pt idx="4">
                  <c:v>1.4166666666666679</c:v>
                </c:pt>
                <c:pt idx="5">
                  <c:v>1.716666666666665</c:v>
                </c:pt>
                <c:pt idx="6">
                  <c:v>0.94999999999999929</c:v>
                </c:pt>
                <c:pt idx="7">
                  <c:v>0.88333333333333286</c:v>
                </c:pt>
              </c:numCache>
            </c:numRef>
          </c:val>
        </c:ser>
        <c:ser>
          <c:idx val="14"/>
          <c:order val="14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P$11:$P$19</c:f>
              <c:numCache>
                <c:formatCode>General</c:formatCode>
                <c:ptCount val="9"/>
                <c:pt idx="0">
                  <c:v>0.29999999999999716</c:v>
                </c:pt>
                <c:pt idx="1">
                  <c:v>10.75</c:v>
                </c:pt>
                <c:pt idx="3">
                  <c:v>5.75</c:v>
                </c:pt>
                <c:pt idx="4">
                  <c:v>15.56666666666667</c:v>
                </c:pt>
                <c:pt idx="5">
                  <c:v>12.733333333333334</c:v>
                </c:pt>
                <c:pt idx="6">
                  <c:v>0.56666666666666643</c:v>
                </c:pt>
                <c:pt idx="7">
                  <c:v>2.56666666666667</c:v>
                </c:pt>
              </c:numCache>
            </c:numRef>
          </c:val>
        </c:ser>
        <c:ser>
          <c:idx val="15"/>
          <c:order val="15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Q$11:$Q$19</c:f>
              <c:numCache>
                <c:formatCode>General</c:formatCode>
                <c:ptCount val="9"/>
                <c:pt idx="3">
                  <c:v>12.216666666666669</c:v>
                </c:pt>
                <c:pt idx="4">
                  <c:v>0.26666666666666572</c:v>
                </c:pt>
                <c:pt idx="5">
                  <c:v>0.3333333333333357</c:v>
                </c:pt>
                <c:pt idx="6">
                  <c:v>6.1833333333333353</c:v>
                </c:pt>
                <c:pt idx="7">
                  <c:v>4.9499999999999957</c:v>
                </c:pt>
              </c:numCache>
            </c:numRef>
          </c:val>
        </c:ser>
        <c:ser>
          <c:idx val="16"/>
          <c:order val="16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R$11:$R$19</c:f>
              <c:numCache>
                <c:formatCode>General</c:formatCode>
                <c:ptCount val="9"/>
                <c:pt idx="3">
                  <c:v>1.0499999999999972</c:v>
                </c:pt>
                <c:pt idx="4">
                  <c:v>3.6666666666666643</c:v>
                </c:pt>
                <c:pt idx="5">
                  <c:v>0.5</c:v>
                </c:pt>
                <c:pt idx="6">
                  <c:v>0.46666666666666501</c:v>
                </c:pt>
                <c:pt idx="7">
                  <c:v>0.4166666666666714</c:v>
                </c:pt>
              </c:numCache>
            </c:numRef>
          </c:val>
        </c:ser>
        <c:ser>
          <c:idx val="17"/>
          <c:order val="17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S$11:$S$19</c:f>
              <c:numCache>
                <c:formatCode>General</c:formatCode>
                <c:ptCount val="9"/>
                <c:pt idx="3">
                  <c:v>1.6333333333333329</c:v>
                </c:pt>
                <c:pt idx="4">
                  <c:v>1.4166666666666643</c:v>
                </c:pt>
                <c:pt idx="5">
                  <c:v>3.5</c:v>
                </c:pt>
                <c:pt idx="6">
                  <c:v>0.53333333333333499</c:v>
                </c:pt>
                <c:pt idx="7">
                  <c:v>10.68333333333333</c:v>
                </c:pt>
              </c:numCache>
            </c:numRef>
          </c:val>
        </c:ser>
        <c:ser>
          <c:idx val="18"/>
          <c:order val="18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T$11:$T$19</c:f>
              <c:numCache>
                <c:formatCode>General</c:formatCode>
                <c:ptCount val="9"/>
                <c:pt idx="3">
                  <c:v>2.1833333333333371</c:v>
                </c:pt>
                <c:pt idx="4">
                  <c:v>2.0833333333333357</c:v>
                </c:pt>
                <c:pt idx="5">
                  <c:v>0.64999999999999858</c:v>
                </c:pt>
                <c:pt idx="6">
                  <c:v>0.54999999999999716</c:v>
                </c:pt>
              </c:numCache>
            </c:numRef>
          </c:val>
        </c:ser>
        <c:ser>
          <c:idx val="19"/>
          <c:order val="19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U$11:$U$19</c:f>
              <c:numCache>
                <c:formatCode>General</c:formatCode>
                <c:ptCount val="9"/>
                <c:pt idx="3">
                  <c:v>5.4499999999999957</c:v>
                </c:pt>
                <c:pt idx="4">
                  <c:v>5.9500000000000028</c:v>
                </c:pt>
                <c:pt idx="5">
                  <c:v>0.85000000000000142</c:v>
                </c:pt>
                <c:pt idx="6">
                  <c:v>0.23333333333333428</c:v>
                </c:pt>
              </c:numCache>
            </c:numRef>
          </c:val>
        </c:ser>
        <c:ser>
          <c:idx val="20"/>
          <c:order val="20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V$11:$V$19</c:f>
              <c:numCache>
                <c:formatCode>General</c:formatCode>
                <c:ptCount val="9"/>
                <c:pt idx="3">
                  <c:v>0.98333333333333428</c:v>
                </c:pt>
                <c:pt idx="4">
                  <c:v>0.96666666666666146</c:v>
                </c:pt>
                <c:pt idx="5">
                  <c:v>0.88333333333333286</c:v>
                </c:pt>
                <c:pt idx="6">
                  <c:v>0.75</c:v>
                </c:pt>
              </c:numCache>
            </c:numRef>
          </c:val>
        </c:ser>
        <c:ser>
          <c:idx val="21"/>
          <c:order val="21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W$11:$W$19</c:f>
              <c:numCache>
                <c:formatCode>General</c:formatCode>
                <c:ptCount val="9"/>
                <c:pt idx="3">
                  <c:v>0.39999999999999858</c:v>
                </c:pt>
                <c:pt idx="4">
                  <c:v>9.5833333333333357</c:v>
                </c:pt>
                <c:pt idx="5">
                  <c:v>1.3166666666666629</c:v>
                </c:pt>
                <c:pt idx="6">
                  <c:v>0.58333333333333215</c:v>
                </c:pt>
              </c:numCache>
            </c:numRef>
          </c:val>
        </c:ser>
        <c:ser>
          <c:idx val="22"/>
          <c:order val="22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X$11:$X$19</c:f>
              <c:numCache>
                <c:formatCode>General</c:formatCode>
                <c:ptCount val="9"/>
                <c:pt idx="3">
                  <c:v>4.4166666666666714</c:v>
                </c:pt>
                <c:pt idx="5">
                  <c:v>0.30000000000000426</c:v>
                </c:pt>
                <c:pt idx="6">
                  <c:v>0.55000000000000071</c:v>
                </c:pt>
              </c:numCache>
            </c:numRef>
          </c:val>
        </c:ser>
        <c:ser>
          <c:idx val="23"/>
          <c:order val="23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Y$11:$Y$19</c:f>
              <c:numCache>
                <c:formatCode>General</c:formatCode>
                <c:ptCount val="9"/>
                <c:pt idx="3">
                  <c:v>5.1666666666666643</c:v>
                </c:pt>
                <c:pt idx="5">
                  <c:v>0.3333333333333286</c:v>
                </c:pt>
                <c:pt idx="6">
                  <c:v>14.2</c:v>
                </c:pt>
              </c:numCache>
            </c:numRef>
          </c:val>
        </c:ser>
        <c:ser>
          <c:idx val="24"/>
          <c:order val="24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Z$11:$Z$19</c:f>
              <c:numCache>
                <c:formatCode>General</c:formatCode>
                <c:ptCount val="9"/>
                <c:pt idx="5">
                  <c:v>4.75</c:v>
                </c:pt>
                <c:pt idx="6">
                  <c:v>0.55000000000000426</c:v>
                </c:pt>
              </c:numCache>
            </c:numRef>
          </c:val>
        </c:ser>
        <c:ser>
          <c:idx val="25"/>
          <c:order val="25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A$11:$AA$19</c:f>
              <c:numCache>
                <c:formatCode>General</c:formatCode>
                <c:ptCount val="9"/>
                <c:pt idx="5">
                  <c:v>0.40000000000000568</c:v>
                </c:pt>
                <c:pt idx="6">
                  <c:v>0.38333333333333286</c:v>
                </c:pt>
              </c:numCache>
            </c:numRef>
          </c:val>
        </c:ser>
        <c:ser>
          <c:idx val="26"/>
          <c:order val="26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B$11:$AB$19</c:f>
              <c:numCache>
                <c:formatCode>General</c:formatCode>
                <c:ptCount val="9"/>
                <c:pt idx="5">
                  <c:v>0.59999999999999432</c:v>
                </c:pt>
                <c:pt idx="6">
                  <c:v>4.8666666666666671</c:v>
                </c:pt>
              </c:numCache>
            </c:numRef>
          </c:val>
        </c:ser>
        <c:ser>
          <c:idx val="27"/>
          <c:order val="27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C$11:$AC$19</c:f>
              <c:numCache>
                <c:formatCode>General</c:formatCode>
                <c:ptCount val="9"/>
                <c:pt idx="5">
                  <c:v>0.13333333333333286</c:v>
                </c:pt>
                <c:pt idx="6">
                  <c:v>0.79999999999999716</c:v>
                </c:pt>
              </c:numCache>
            </c:numRef>
          </c:val>
        </c:ser>
        <c:ser>
          <c:idx val="28"/>
          <c:order val="28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D$11:$AD$19</c:f>
              <c:numCache>
                <c:formatCode>General</c:formatCode>
                <c:ptCount val="9"/>
                <c:pt idx="5">
                  <c:v>0.28333333333333854</c:v>
                </c:pt>
                <c:pt idx="6">
                  <c:v>1.5166666666666657</c:v>
                </c:pt>
              </c:numCache>
            </c:numRef>
          </c:val>
        </c:ser>
        <c:ser>
          <c:idx val="29"/>
          <c:order val="29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E$11:$AE$19</c:f>
              <c:numCache>
                <c:formatCode>General</c:formatCode>
                <c:ptCount val="9"/>
                <c:pt idx="5">
                  <c:v>1.6666666666666643</c:v>
                </c:pt>
                <c:pt idx="6">
                  <c:v>5.8000000000000043</c:v>
                </c:pt>
              </c:numCache>
            </c:numRef>
          </c:val>
        </c:ser>
        <c:ser>
          <c:idx val="30"/>
          <c:order val="30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F$11:$AF$19</c:f>
              <c:numCache>
                <c:formatCode>General</c:formatCode>
                <c:ptCount val="9"/>
                <c:pt idx="5">
                  <c:v>1.18333333333333</c:v>
                </c:pt>
                <c:pt idx="6">
                  <c:v>0.86666666666666003</c:v>
                </c:pt>
              </c:numCache>
            </c:numRef>
          </c:val>
        </c:ser>
        <c:ser>
          <c:idx val="31"/>
          <c:order val="31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G$11:$AG$19</c:f>
              <c:numCache>
                <c:formatCode>General</c:formatCode>
                <c:ptCount val="9"/>
                <c:pt idx="5">
                  <c:v>1.1500000000000057</c:v>
                </c:pt>
                <c:pt idx="6">
                  <c:v>0.21666666666666856</c:v>
                </c:pt>
              </c:numCache>
            </c:numRef>
          </c:val>
        </c:ser>
        <c:ser>
          <c:idx val="32"/>
          <c:order val="32"/>
          <c:invertIfNegative val="0"/>
          <c:cat>
            <c:strRef>
              <c:f>Sheet1!$A$11:$A$19</c:f>
              <c:strCache>
                <c:ptCount val="9"/>
                <c:pt idx="0">
                  <c:v>Rater 9</c:v>
                </c:pt>
                <c:pt idx="1">
                  <c:v>Rater 8</c:v>
                </c:pt>
                <c:pt idx="2">
                  <c:v>Rater 7</c:v>
                </c:pt>
                <c:pt idx="3">
                  <c:v>Rater 6</c:v>
                </c:pt>
                <c:pt idx="4">
                  <c:v>Rater 5</c:v>
                </c:pt>
                <c:pt idx="5">
                  <c:v>Rater 4</c:v>
                </c:pt>
                <c:pt idx="6">
                  <c:v>Rater 3</c:v>
                </c:pt>
                <c:pt idx="7">
                  <c:v>Rater 2</c:v>
                </c:pt>
                <c:pt idx="8">
                  <c:v>Rater 1</c:v>
                </c:pt>
              </c:strCache>
            </c:strRef>
          </c:cat>
          <c:val>
            <c:numRef>
              <c:f>Sheet1!$AH$11:$AH$19</c:f>
              <c:numCache>
                <c:formatCode>General</c:formatCode>
                <c:ptCount val="9"/>
                <c:pt idx="5">
                  <c:v>5.6666666666666643</c:v>
                </c:pt>
                <c:pt idx="6">
                  <c:v>9.60000000000000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85488328"/>
        <c:axId val="385488720"/>
      </c:barChart>
      <c:catAx>
        <c:axId val="385488328"/>
        <c:scaling>
          <c:orientation val="minMax"/>
        </c:scaling>
        <c:delete val="0"/>
        <c:axPos val="l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385488720"/>
        <c:crosses val="autoZero"/>
        <c:auto val="1"/>
        <c:lblAlgn val="ctr"/>
        <c:lblOffset val="100"/>
        <c:noMultiLvlLbl val="0"/>
      </c:catAx>
      <c:valAx>
        <c:axId val="385488720"/>
        <c:scaling>
          <c:orientation val="minMax"/>
          <c:max val="64"/>
          <c:min val="0"/>
        </c:scaling>
        <c:delete val="0"/>
        <c:axPos val="b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de-DE"/>
          </a:p>
        </c:txPr>
        <c:crossAx val="385488328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440180" y="1988397"/>
            <a:ext cx="16322040" cy="137202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2880360" y="3627120"/>
            <a:ext cx="13441680" cy="16357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4804350" y="204470"/>
            <a:ext cx="10801350" cy="436943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400300" y="204470"/>
            <a:ext cx="32084010" cy="436943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16858" y="4113107"/>
            <a:ext cx="16322040" cy="127127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1516858" y="2712933"/>
            <a:ext cx="16322040" cy="140017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400300" y="1194223"/>
            <a:ext cx="21442680" cy="337968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4163020" y="1194223"/>
            <a:ext cx="21442680" cy="337968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0120" y="256328"/>
            <a:ext cx="17282160" cy="10668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0120" y="1432772"/>
            <a:ext cx="8484395" cy="5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960120" y="2029884"/>
            <a:ext cx="8484395" cy="36878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9754554" y="1432772"/>
            <a:ext cx="8487728" cy="5971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9754554" y="2029884"/>
            <a:ext cx="8487728" cy="36878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960121" y="254847"/>
            <a:ext cx="6317458" cy="10845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7507605" y="254848"/>
            <a:ext cx="10734675" cy="54629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960121" y="1339428"/>
            <a:ext cx="6317458" cy="43783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763805" y="4480560"/>
            <a:ext cx="11521440" cy="52895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3763805" y="571923"/>
            <a:ext cx="11521440" cy="38404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763805" y="5009515"/>
            <a:ext cx="11521440" cy="75120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960120" y="256328"/>
            <a:ext cx="17282160" cy="106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960120" y="1493521"/>
            <a:ext cx="17282160" cy="42242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960120" y="5932594"/>
            <a:ext cx="448056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7D9D62-54F7-4142-BA80-C0DF2C398D89}" type="datetimeFigureOut">
              <a:rPr lang="de-DE" smtClean="0"/>
              <a:t>15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6560820" y="5932594"/>
            <a:ext cx="608076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13761720" y="5932594"/>
            <a:ext cx="4480560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223554-8103-465C-BAB6-2BBFC26F4E8D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9" name="Gerade Verbindung 18"/>
          <p:cNvCxnSpPr/>
          <p:nvPr/>
        </p:nvCxnSpPr>
        <p:spPr>
          <a:xfrm>
            <a:off x="1939159" y="848784"/>
            <a:ext cx="15749751" cy="0"/>
          </a:xfrm>
          <a:prstGeom prst="line">
            <a:avLst/>
          </a:prstGeom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" name="Chart 2"/>
          <p:cNvGraphicFramePr/>
          <p:nvPr>
            <p:extLst>
              <p:ext uri="{D42A27DB-BD31-4B8C-83A1-F6EECF244321}">
                <p14:modId xmlns:p14="http://schemas.microsoft.com/office/powerpoint/2010/main" val="102637315"/>
              </p:ext>
            </p:extLst>
          </p:nvPr>
        </p:nvGraphicFramePr>
        <p:xfrm>
          <a:off x="1313259" y="709357"/>
          <a:ext cx="16575882" cy="5229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Gerade Verbindung 5"/>
          <p:cNvCxnSpPr/>
          <p:nvPr/>
        </p:nvCxnSpPr>
        <p:spPr>
          <a:xfrm flipV="1">
            <a:off x="2402977" y="669835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8"/>
          <p:cNvCxnSpPr/>
          <p:nvPr/>
        </p:nvCxnSpPr>
        <p:spPr>
          <a:xfrm flipV="1">
            <a:off x="4340568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 Verbindung 9"/>
          <p:cNvCxnSpPr/>
          <p:nvPr/>
        </p:nvCxnSpPr>
        <p:spPr>
          <a:xfrm flipV="1">
            <a:off x="5559631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10"/>
          <p:cNvCxnSpPr/>
          <p:nvPr/>
        </p:nvCxnSpPr>
        <p:spPr>
          <a:xfrm flipV="1">
            <a:off x="7250021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11"/>
          <p:cNvCxnSpPr/>
          <p:nvPr/>
        </p:nvCxnSpPr>
        <p:spPr>
          <a:xfrm flipV="1">
            <a:off x="8033793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12"/>
          <p:cNvCxnSpPr/>
          <p:nvPr/>
        </p:nvCxnSpPr>
        <p:spPr>
          <a:xfrm flipV="1">
            <a:off x="11679517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13"/>
          <p:cNvCxnSpPr/>
          <p:nvPr/>
        </p:nvCxnSpPr>
        <p:spPr>
          <a:xfrm flipV="1">
            <a:off x="13078826" y="665877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14"/>
          <p:cNvCxnSpPr/>
          <p:nvPr/>
        </p:nvCxnSpPr>
        <p:spPr>
          <a:xfrm flipV="1">
            <a:off x="13650820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15"/>
          <p:cNvCxnSpPr/>
          <p:nvPr/>
        </p:nvCxnSpPr>
        <p:spPr>
          <a:xfrm flipV="1">
            <a:off x="14945232" y="667856"/>
            <a:ext cx="3823" cy="495590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1876098" y="312762"/>
            <a:ext cx="16411903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900" dirty="0" smtClean="0"/>
              <a:t>❶                 ❷                        ❸                    ❹                  ❺                                  ❻                                          ❼            ❽           ❾                               ❿</a:t>
            </a:r>
            <a:endParaRPr lang="de-DE" sz="19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FR</dc:creator>
  <cp:lastModifiedBy>John Rauthmann</cp:lastModifiedBy>
  <cp:revision>6</cp:revision>
  <dcterms:created xsi:type="dcterms:W3CDTF">2015-07-13T07:12:20Z</dcterms:created>
  <dcterms:modified xsi:type="dcterms:W3CDTF">2015-07-15T14:42:44Z</dcterms:modified>
</cp:coreProperties>
</file>